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7" autoAdjust="0"/>
    <p:restoredTop sz="94660"/>
  </p:normalViewPr>
  <p:slideViewPr>
    <p:cSldViewPr snapToGrid="0">
      <p:cViewPr>
        <p:scale>
          <a:sx n="190" d="100"/>
          <a:sy n="190" d="100"/>
        </p:scale>
        <p:origin x="-2538" y="2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2B96B6-B90F-48A5-96C9-4D2AE5BE985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D1A994D-8AE1-45E8-B9FE-BEF7BD4063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4B928B-8C23-4F5D-BC3B-20FEE59B6F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C8420-BBEE-4EBD-B9FB-B62ADA2BB064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25D0D1-7748-417D-9D84-C369B1E42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D32848-84FB-4AE4-8126-22BB29B59D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D7D76-6E83-491B-AB6D-5B67AF74B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0177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4276E8-6680-4613-B97E-5CF90FF647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B4E776-181A-41C6-BBF4-019D491E6A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18DE20-58A4-4DCF-9B60-8FFBB2171D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C8420-BBEE-4EBD-B9FB-B62ADA2BB064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3B5775-1CF1-4E5C-AF90-DFB21D43D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1651A0-5BEA-49F9-851A-C081999A13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D7D76-6E83-491B-AB6D-5B67AF74B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689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7B7D7CE-81AB-4B41-9F4E-7198EFBA5E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FEF987A-9687-4A47-942D-3912E1FAA6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169AAF-5F95-4B83-8AC4-DA77E19DFD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C8420-BBEE-4EBD-B9FB-B62ADA2BB064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091D42-C2C5-4EF8-ACE0-1C1085582D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48E26E-01B7-4B89-9737-FD90B74300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D7D76-6E83-491B-AB6D-5B67AF74B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360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D22505-D126-4E70-B486-F639264D35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45BBD7-EECF-472C-968A-E9399CC930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563A2C-0FC2-42B0-87ED-0D067CEF06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C8420-BBEE-4EBD-B9FB-B62ADA2BB064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CE35D7-29D5-4CA3-89C1-B4E4CCD908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9CE2AA-4F3E-41BC-BA19-DB83713E91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D7D76-6E83-491B-AB6D-5B67AF74B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216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373F95-A98A-4FFE-8066-E32BEB2C33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CA8699-E6E4-4682-87A0-E99558E9F2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51A774-BDF4-4B4F-A341-6765984366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C8420-BBEE-4EBD-B9FB-B62ADA2BB064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BC1018-41A6-4A7D-8A64-7BF7558CC6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D0EB22-831F-4A92-A3BE-A12FA7FECA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D7D76-6E83-491B-AB6D-5B67AF74B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12980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33AC8B-DCB9-45B8-B0C4-937F8748D7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C1BE6D-BF6F-4759-AE7A-A1702949DD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273960-6280-4FCC-8458-541CAAABE9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6FC273-4CD2-41CD-9530-06C9F9F358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C8420-BBEE-4EBD-B9FB-B62ADA2BB064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D51140-7A37-43FC-A58B-E7FA91A10B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22C60C-7F8A-4B8B-8E78-CD2D980110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D7D76-6E83-491B-AB6D-5B67AF74B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5452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4AB55A-05FD-4798-AC89-B8AFA5220A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4E0DC4-EA54-4D7A-92C5-68AC29E765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130C56-2C75-4492-B04F-1DC5B7B648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5B34D99-6B6A-4A7A-9F7A-DA6C972BC1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05D4712-4834-4E4E-A75E-05C3221D5C8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E0B4CCC-DB03-4986-BDAE-82CDFA32C4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C8420-BBEE-4EBD-B9FB-B62ADA2BB064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202D49D-7C69-4FBC-8784-2110FC70B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54EC752-DBCF-488C-87B2-C8D6FFCC39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D7D76-6E83-491B-AB6D-5B67AF74B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4145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E4E9CD-A17B-47A2-B00D-126C16F2A7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87D31C-CACE-4A7B-9D4F-59BA151E8F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C8420-BBEE-4EBD-B9FB-B62ADA2BB064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9084724-26FB-41D0-9737-568C3BC60F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45B24BC-3C98-4DB5-9313-27610C750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D7D76-6E83-491B-AB6D-5B67AF74B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417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129E80D-CCEE-4293-80AD-7953300550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C8420-BBEE-4EBD-B9FB-B62ADA2BB064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DAE37D3-F4ED-4B27-9350-E472299DF3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1B72B23-C76B-456B-9E42-7743A9FF6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D7D76-6E83-491B-AB6D-5B67AF74B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1432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21D6DB-D0A7-4FCA-9D4B-08A23A0426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9ED69F-8D09-4C60-B06A-F823D615C7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11A3BB-4775-4595-A1AB-369F0CEC73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FF55B2-B8FA-4FC1-ACD6-68B2FEF427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C8420-BBEE-4EBD-B9FB-B62ADA2BB064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F8091B-A335-4E9F-B300-3FDC29D5E7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BC90D3-2F1A-4F49-A5FE-E89EA634C3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D7D76-6E83-491B-AB6D-5B67AF74B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4998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E5468B-0F79-4FFF-87A0-042D4E7943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724DE55-A0B0-4216-A6FE-789D4AC9D1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0B19A4-48AE-4D42-BA71-6574C2F03A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63E02E-D6C5-45A0-9551-0C582E6D3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C8420-BBEE-4EBD-B9FB-B62ADA2BB064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EACF7B-2B09-4586-8C83-5E2DDC4DB0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08BFEC-85E9-4692-B29D-D2CF075CE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6D7D76-6E83-491B-AB6D-5B67AF74B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29317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85F9406-940C-452F-8BCD-9200749236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D98F30-130D-49F6-8CD9-E68A8BA4F2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8F2ADE-A8F2-425A-AFAA-F952C024F5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AC8420-BBEE-4EBD-B9FB-B62ADA2BB064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AB6B71-573D-4981-94D0-BF94DEE5AA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D66ACF-DD28-4BA8-9AD3-5E113C829F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6D7D76-6E83-491B-AB6D-5B67AF74B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2688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06D20AD-564B-4144-934D-8084F0924A3C}"/>
              </a:ext>
            </a:extLst>
          </p:cNvPr>
          <p:cNvSpPr txBox="1"/>
          <p:nvPr/>
        </p:nvSpPr>
        <p:spPr>
          <a:xfrm>
            <a:off x="2190961" y="1404315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99E213D-CD16-41BD-996E-53CC2509925A}"/>
              </a:ext>
            </a:extLst>
          </p:cNvPr>
          <p:cNvSpPr txBox="1"/>
          <p:nvPr/>
        </p:nvSpPr>
        <p:spPr>
          <a:xfrm>
            <a:off x="4121093" y="1404315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E40C1D3-4E2B-4925-8996-9F307A78477B}"/>
              </a:ext>
            </a:extLst>
          </p:cNvPr>
          <p:cNvSpPr txBox="1"/>
          <p:nvPr/>
        </p:nvSpPr>
        <p:spPr>
          <a:xfrm>
            <a:off x="4723998" y="1208362"/>
            <a:ext cx="74090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RC7-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7" name="Isosceles Triangle 6">
            <a:extLst>
              <a:ext uri="{FF2B5EF4-FFF2-40B4-BE49-F238E27FC236}">
                <a16:creationId xmlns:a16="http://schemas.microsoft.com/office/drawing/2014/main" id="{E5EECEE6-E95D-4B77-86CA-D4B8A99AFA42}"/>
              </a:ext>
            </a:extLst>
          </p:cNvPr>
          <p:cNvSpPr/>
          <p:nvPr/>
        </p:nvSpPr>
        <p:spPr>
          <a:xfrm>
            <a:off x="2270753" y="1647501"/>
            <a:ext cx="574011" cy="157593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C96A8D9-51D6-40B5-BA3B-00DA0B028B19}"/>
              </a:ext>
            </a:extLst>
          </p:cNvPr>
          <p:cNvSpPr txBox="1"/>
          <p:nvPr/>
        </p:nvSpPr>
        <p:spPr>
          <a:xfrm>
            <a:off x="2845676" y="1208362"/>
            <a:ext cx="82266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RC2-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1221P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D8E7C14-5260-48F6-877B-4142F9E814BA}"/>
              </a:ext>
            </a:extLst>
          </p:cNvPr>
          <p:cNvSpPr txBox="1"/>
          <p:nvPr/>
        </p:nvSpPr>
        <p:spPr>
          <a:xfrm>
            <a:off x="2122976" y="177643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20CC4B2-74B6-4164-BCC0-1718D463264D}"/>
              </a:ext>
            </a:extLst>
          </p:cNvPr>
          <p:cNvSpPr txBox="1"/>
          <p:nvPr/>
        </p:nvSpPr>
        <p:spPr>
          <a:xfrm>
            <a:off x="1188753" y="2432327"/>
            <a:ext cx="654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ssDNA*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1AD1456-4475-4EEB-A2C9-B8BBD73A0B6B}"/>
              </a:ext>
            </a:extLst>
          </p:cNvPr>
          <p:cNvSpPr txBox="1"/>
          <p:nvPr/>
        </p:nvSpPr>
        <p:spPr>
          <a:xfrm>
            <a:off x="988628" y="1886057"/>
            <a:ext cx="9106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BRC-RAD51-ssDNA*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AE6DAC43-7F83-4D2B-8490-5DC1D45132F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646" t="28181" r="37620" b="60067"/>
          <a:stretch/>
        </p:blipFill>
        <p:spPr>
          <a:xfrm>
            <a:off x="3779306" y="1939680"/>
            <a:ext cx="1784144" cy="7647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DF4520A-D1D2-4C53-9CA5-ABA0CD6AC50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49" t="9345" r="37430" b="78819"/>
          <a:stretch/>
        </p:blipFill>
        <p:spPr>
          <a:xfrm>
            <a:off x="1783775" y="1944960"/>
            <a:ext cx="1806484" cy="75944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7E75FCE0-0671-4482-B91C-C83467A76E67}"/>
              </a:ext>
            </a:extLst>
          </p:cNvPr>
          <p:cNvSpPr txBox="1"/>
          <p:nvPr/>
        </p:nvSpPr>
        <p:spPr>
          <a:xfrm>
            <a:off x="2794027" y="177643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AB42C5B-E3BB-4FA5-B690-43F6A0B94CA1}"/>
              </a:ext>
            </a:extLst>
          </p:cNvPr>
          <p:cNvSpPr txBox="1"/>
          <p:nvPr/>
        </p:nvSpPr>
        <p:spPr>
          <a:xfrm rot="16200000">
            <a:off x="1791201" y="1525958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45799A8-1E21-449A-B2AD-0413D272396D}"/>
              </a:ext>
            </a:extLst>
          </p:cNvPr>
          <p:cNvSpPr txBox="1"/>
          <p:nvPr/>
        </p:nvSpPr>
        <p:spPr>
          <a:xfrm rot="16200000">
            <a:off x="1435659" y="1393782"/>
            <a:ext cx="955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o protein</a:t>
            </a:r>
          </a:p>
        </p:txBody>
      </p:sp>
      <p:sp>
        <p:nvSpPr>
          <p:cNvPr id="17" name="Isosceles Triangle 16">
            <a:extLst>
              <a:ext uri="{FF2B5EF4-FFF2-40B4-BE49-F238E27FC236}">
                <a16:creationId xmlns:a16="http://schemas.microsoft.com/office/drawing/2014/main" id="{536DB619-2B68-4AA9-AAAF-194AD318D36F}"/>
              </a:ext>
            </a:extLst>
          </p:cNvPr>
          <p:cNvSpPr/>
          <p:nvPr/>
        </p:nvSpPr>
        <p:spPr>
          <a:xfrm>
            <a:off x="2976847" y="1647501"/>
            <a:ext cx="574011" cy="157593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Isosceles Triangle 17">
            <a:extLst>
              <a:ext uri="{FF2B5EF4-FFF2-40B4-BE49-F238E27FC236}">
                <a16:creationId xmlns:a16="http://schemas.microsoft.com/office/drawing/2014/main" id="{40CE4A0A-87A7-4B20-A3E0-F94FC5BB1D53}"/>
              </a:ext>
            </a:extLst>
          </p:cNvPr>
          <p:cNvSpPr/>
          <p:nvPr/>
        </p:nvSpPr>
        <p:spPr>
          <a:xfrm>
            <a:off x="4189129" y="1647501"/>
            <a:ext cx="574011" cy="157593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3823F94-A2FE-475B-8158-6111CAEEF2D9}"/>
              </a:ext>
            </a:extLst>
          </p:cNvPr>
          <p:cNvSpPr txBox="1"/>
          <p:nvPr/>
        </p:nvSpPr>
        <p:spPr>
          <a:xfrm>
            <a:off x="4031123" y="1774124"/>
            <a:ext cx="6751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5 0.5  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A06B0A4-D822-4C11-AE6B-120CD4064B61}"/>
              </a:ext>
            </a:extLst>
          </p:cNvPr>
          <p:cNvSpPr txBox="1"/>
          <p:nvPr/>
        </p:nvSpPr>
        <p:spPr>
          <a:xfrm rot="16200000">
            <a:off x="3708311" y="1525958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D6772CA-66FB-4090-8119-134C28ED3032}"/>
              </a:ext>
            </a:extLst>
          </p:cNvPr>
          <p:cNvSpPr txBox="1"/>
          <p:nvPr/>
        </p:nvSpPr>
        <p:spPr>
          <a:xfrm rot="16200000">
            <a:off x="3404877" y="1393782"/>
            <a:ext cx="955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o protein</a:t>
            </a:r>
          </a:p>
        </p:txBody>
      </p:sp>
      <p:sp>
        <p:nvSpPr>
          <p:cNvPr id="22" name="Isosceles Triangle 21">
            <a:extLst>
              <a:ext uri="{FF2B5EF4-FFF2-40B4-BE49-F238E27FC236}">
                <a16:creationId xmlns:a16="http://schemas.microsoft.com/office/drawing/2014/main" id="{6571E0EE-DDEC-422F-9C10-79CAAD531022}"/>
              </a:ext>
            </a:extLst>
          </p:cNvPr>
          <p:cNvSpPr/>
          <p:nvPr/>
        </p:nvSpPr>
        <p:spPr>
          <a:xfrm>
            <a:off x="4854720" y="1647501"/>
            <a:ext cx="574011" cy="157593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9285B9C-EA10-409F-8F77-602BB005AD26}"/>
              </a:ext>
            </a:extLst>
          </p:cNvPr>
          <p:cNvSpPr txBox="1"/>
          <p:nvPr/>
        </p:nvSpPr>
        <p:spPr>
          <a:xfrm>
            <a:off x="1713032" y="2677301"/>
            <a:ext cx="19479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   2   3   4    5   6    7   8   9  1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83C7EB0-7EB5-434C-92DD-8EC06D6B97F8}"/>
              </a:ext>
            </a:extLst>
          </p:cNvPr>
          <p:cNvSpPr txBox="1"/>
          <p:nvPr/>
        </p:nvSpPr>
        <p:spPr>
          <a:xfrm>
            <a:off x="3734396" y="2677301"/>
            <a:ext cx="1983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   2   3   4   5    6   7   8   9  1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5CE3F44-AD73-4200-84FF-DEAD5A8B33A7}"/>
              </a:ext>
            </a:extLst>
          </p:cNvPr>
          <p:cNvSpPr txBox="1"/>
          <p:nvPr/>
        </p:nvSpPr>
        <p:spPr>
          <a:xfrm>
            <a:off x="864625" y="1074225"/>
            <a:ext cx="324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7B7583A-68B4-4D59-871F-FE5A81D11985}"/>
              </a:ext>
            </a:extLst>
          </p:cNvPr>
          <p:cNvSpPr txBox="1"/>
          <p:nvPr/>
        </p:nvSpPr>
        <p:spPr>
          <a:xfrm>
            <a:off x="2344547" y="1776438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DC7D128-616E-4E7E-ACD0-D9CE5A66A7CE}"/>
              </a:ext>
            </a:extLst>
          </p:cNvPr>
          <p:cNvSpPr txBox="1"/>
          <p:nvPr/>
        </p:nvSpPr>
        <p:spPr>
          <a:xfrm>
            <a:off x="2531438" y="177643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28B401E-4AB4-4CB4-8A54-5E43B199D419}"/>
              </a:ext>
            </a:extLst>
          </p:cNvPr>
          <p:cNvSpPr txBox="1"/>
          <p:nvPr/>
        </p:nvSpPr>
        <p:spPr>
          <a:xfrm>
            <a:off x="2703068" y="1776438"/>
            <a:ext cx="1623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0ABF8C3-BE4D-4C4D-A2DD-A548FE650231}"/>
              </a:ext>
            </a:extLst>
          </p:cNvPr>
          <p:cNvSpPr txBox="1"/>
          <p:nvPr/>
        </p:nvSpPr>
        <p:spPr>
          <a:xfrm>
            <a:off x="3022064" y="1776438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E5A35F3-7E70-49EB-8C8D-401F3AC1703B}"/>
              </a:ext>
            </a:extLst>
          </p:cNvPr>
          <p:cNvSpPr txBox="1"/>
          <p:nvPr/>
        </p:nvSpPr>
        <p:spPr>
          <a:xfrm>
            <a:off x="3202561" y="177643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0C6E484-C0A5-44B7-A04C-327F1F906DA7}"/>
              </a:ext>
            </a:extLst>
          </p:cNvPr>
          <p:cNvSpPr txBox="1"/>
          <p:nvPr/>
        </p:nvSpPr>
        <p:spPr>
          <a:xfrm>
            <a:off x="3386979" y="1776438"/>
            <a:ext cx="1623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DB507FA-7B08-4E87-B4F3-8EC556A975E1}"/>
              </a:ext>
            </a:extLst>
          </p:cNvPr>
          <p:cNvSpPr txBox="1"/>
          <p:nvPr/>
        </p:nvSpPr>
        <p:spPr>
          <a:xfrm>
            <a:off x="4938640" y="1774124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61F40FE-73FF-440B-85FF-ED1A1A73EEA8}"/>
              </a:ext>
            </a:extLst>
          </p:cNvPr>
          <p:cNvSpPr txBox="1"/>
          <p:nvPr/>
        </p:nvSpPr>
        <p:spPr>
          <a:xfrm>
            <a:off x="5139995" y="177412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19C2A12-43E6-4E2B-84BE-C136FB4EE58E}"/>
              </a:ext>
            </a:extLst>
          </p:cNvPr>
          <p:cNvSpPr txBox="1"/>
          <p:nvPr/>
        </p:nvSpPr>
        <p:spPr>
          <a:xfrm>
            <a:off x="4631150" y="1774124"/>
            <a:ext cx="1623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DBFE1DC-D7E6-4986-B2DF-6E47CDBC56AB}"/>
              </a:ext>
            </a:extLst>
          </p:cNvPr>
          <p:cNvSpPr txBox="1"/>
          <p:nvPr/>
        </p:nvSpPr>
        <p:spPr>
          <a:xfrm>
            <a:off x="4727824" y="177412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E23238E-2927-4E74-ACCD-BD960D3CEEB5}"/>
              </a:ext>
            </a:extLst>
          </p:cNvPr>
          <p:cNvSpPr txBox="1"/>
          <p:nvPr/>
        </p:nvSpPr>
        <p:spPr>
          <a:xfrm>
            <a:off x="5317426" y="1774124"/>
            <a:ext cx="1623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D4DDE4D-F9FD-41B7-AE38-C8EAE4F89A6B}"/>
              </a:ext>
            </a:extLst>
          </p:cNvPr>
          <p:cNvSpPr txBox="1"/>
          <p:nvPr/>
        </p:nvSpPr>
        <p:spPr>
          <a:xfrm>
            <a:off x="5485246" y="1764213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µM)</a:t>
            </a:r>
          </a:p>
        </p:txBody>
      </p:sp>
      <p:pic>
        <p:nvPicPr>
          <p:cNvPr id="39" name="Picture 38" descr="Diagram&#10;&#10;Description automatically generated">
            <a:extLst>
              <a:ext uri="{FF2B5EF4-FFF2-40B4-BE49-F238E27FC236}">
                <a16:creationId xmlns:a16="http://schemas.microsoft.com/office/drawing/2014/main" id="{467B02D0-0D03-407E-8EA8-7936EB4A115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14389" y="128336"/>
            <a:ext cx="5630906" cy="6858000"/>
          </a:xfrm>
          <a:prstGeom prst="rect">
            <a:avLst/>
          </a:prstGeom>
        </p:spPr>
      </p:pic>
      <p:sp>
        <p:nvSpPr>
          <p:cNvPr id="40" name="Rectangle 39">
            <a:extLst>
              <a:ext uri="{FF2B5EF4-FFF2-40B4-BE49-F238E27FC236}">
                <a16:creationId xmlns:a16="http://schemas.microsoft.com/office/drawing/2014/main" id="{49013C2A-5796-4F1D-931C-3146F5FADF10}"/>
              </a:ext>
            </a:extLst>
          </p:cNvPr>
          <p:cNvSpPr/>
          <p:nvPr/>
        </p:nvSpPr>
        <p:spPr>
          <a:xfrm>
            <a:off x="8061159" y="633662"/>
            <a:ext cx="1580147" cy="9946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B0C132B2-B16C-423D-B17F-482556D7379B}"/>
              </a:ext>
            </a:extLst>
          </p:cNvPr>
          <p:cNvSpPr/>
          <p:nvPr/>
        </p:nvSpPr>
        <p:spPr>
          <a:xfrm>
            <a:off x="8039768" y="2000271"/>
            <a:ext cx="1580147" cy="9946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8BB80B3-76B5-47E9-8CE5-0A84A5B49E5B}"/>
              </a:ext>
            </a:extLst>
          </p:cNvPr>
          <p:cNvSpPr txBox="1"/>
          <p:nvPr/>
        </p:nvSpPr>
        <p:spPr>
          <a:xfrm>
            <a:off x="8533155" y="350734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43" name="Isosceles Triangle 42">
            <a:extLst>
              <a:ext uri="{FF2B5EF4-FFF2-40B4-BE49-F238E27FC236}">
                <a16:creationId xmlns:a16="http://schemas.microsoft.com/office/drawing/2014/main" id="{8BEA5E9E-C598-4E28-9804-63CAB6052D6A}"/>
              </a:ext>
            </a:extLst>
          </p:cNvPr>
          <p:cNvSpPr/>
          <p:nvPr/>
        </p:nvSpPr>
        <p:spPr>
          <a:xfrm>
            <a:off x="8543217" y="508512"/>
            <a:ext cx="481759" cy="157593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8FCCE1A-17FE-4ADC-AF3E-D9062C654391}"/>
              </a:ext>
            </a:extLst>
          </p:cNvPr>
          <p:cNvSpPr txBox="1"/>
          <p:nvPr/>
        </p:nvSpPr>
        <p:spPr>
          <a:xfrm>
            <a:off x="9080489" y="154781"/>
            <a:ext cx="6367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RC2-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1221P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2CAD919-537A-4F0A-92C0-6FCFBF5D9547}"/>
              </a:ext>
            </a:extLst>
          </p:cNvPr>
          <p:cNvSpPr txBox="1"/>
          <p:nvPr/>
        </p:nvSpPr>
        <p:spPr>
          <a:xfrm>
            <a:off x="8395440" y="637449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340858A-81BD-45D1-B5E4-C2A736E52B1D}"/>
              </a:ext>
            </a:extLst>
          </p:cNvPr>
          <p:cNvSpPr txBox="1"/>
          <p:nvPr/>
        </p:nvSpPr>
        <p:spPr>
          <a:xfrm>
            <a:off x="8930841" y="637449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414649D-960F-49E7-88B6-7EF0B4536747}"/>
              </a:ext>
            </a:extLst>
          </p:cNvPr>
          <p:cNvSpPr txBox="1"/>
          <p:nvPr/>
        </p:nvSpPr>
        <p:spPr>
          <a:xfrm rot="16200000">
            <a:off x="8104541" y="487766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55A2253-6DD9-4FCD-AD8E-8609CED4FC80}"/>
              </a:ext>
            </a:extLst>
          </p:cNvPr>
          <p:cNvSpPr txBox="1"/>
          <p:nvPr/>
        </p:nvSpPr>
        <p:spPr>
          <a:xfrm rot="16200000">
            <a:off x="7773045" y="355590"/>
            <a:ext cx="8258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protein</a:t>
            </a:r>
          </a:p>
        </p:txBody>
      </p:sp>
      <p:sp>
        <p:nvSpPr>
          <p:cNvPr id="49" name="Isosceles Triangle 48">
            <a:extLst>
              <a:ext uri="{FF2B5EF4-FFF2-40B4-BE49-F238E27FC236}">
                <a16:creationId xmlns:a16="http://schemas.microsoft.com/office/drawing/2014/main" id="{3030017F-A215-4E04-A5D4-8D32DAB0634D}"/>
              </a:ext>
            </a:extLst>
          </p:cNvPr>
          <p:cNvSpPr/>
          <p:nvPr/>
        </p:nvSpPr>
        <p:spPr>
          <a:xfrm>
            <a:off x="9098591" y="508512"/>
            <a:ext cx="457312" cy="157593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C657E44-8747-40B2-B0C6-B012BD9A972B}"/>
              </a:ext>
            </a:extLst>
          </p:cNvPr>
          <p:cNvSpPr txBox="1"/>
          <p:nvPr/>
        </p:nvSpPr>
        <p:spPr>
          <a:xfrm>
            <a:off x="8581843" y="637449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C8E4032-2CE0-43CF-AD67-6073B118EE68}"/>
              </a:ext>
            </a:extLst>
          </p:cNvPr>
          <p:cNvSpPr txBox="1"/>
          <p:nvPr/>
        </p:nvSpPr>
        <p:spPr>
          <a:xfrm>
            <a:off x="8748638" y="63744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4FDA4CE-CC16-466C-BE4E-072E48FD7381}"/>
              </a:ext>
            </a:extLst>
          </p:cNvPr>
          <p:cNvSpPr txBox="1"/>
          <p:nvPr/>
        </p:nvSpPr>
        <p:spPr>
          <a:xfrm>
            <a:off x="8884242" y="633663"/>
            <a:ext cx="122177" cy="2192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81E426B-101D-46E0-9AF0-6E41001B1EF3}"/>
              </a:ext>
            </a:extLst>
          </p:cNvPr>
          <p:cNvSpPr txBox="1"/>
          <p:nvPr/>
        </p:nvSpPr>
        <p:spPr>
          <a:xfrm>
            <a:off x="9138779" y="637449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6692080-660A-4B3F-AB37-93032DC1E114}"/>
              </a:ext>
            </a:extLst>
          </p:cNvPr>
          <p:cNvSpPr txBox="1"/>
          <p:nvPr/>
        </p:nvSpPr>
        <p:spPr>
          <a:xfrm>
            <a:off x="9284111" y="63744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8182249-F66A-4049-9D3B-9B01BFAABEEF}"/>
              </a:ext>
            </a:extLst>
          </p:cNvPr>
          <p:cNvSpPr txBox="1"/>
          <p:nvPr/>
        </p:nvSpPr>
        <p:spPr>
          <a:xfrm>
            <a:off x="9378089" y="637449"/>
            <a:ext cx="1623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DD9ACA0-3096-4B8F-ABA2-C4E01CA5A2C8}"/>
              </a:ext>
            </a:extLst>
          </p:cNvPr>
          <p:cNvSpPr txBox="1"/>
          <p:nvPr/>
        </p:nvSpPr>
        <p:spPr>
          <a:xfrm>
            <a:off x="8532282" y="1691039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57" name="Isosceles Triangle 56">
            <a:extLst>
              <a:ext uri="{FF2B5EF4-FFF2-40B4-BE49-F238E27FC236}">
                <a16:creationId xmlns:a16="http://schemas.microsoft.com/office/drawing/2014/main" id="{D7FE5151-E3EC-473E-8810-ABBBF30B93CD}"/>
              </a:ext>
            </a:extLst>
          </p:cNvPr>
          <p:cNvSpPr/>
          <p:nvPr/>
        </p:nvSpPr>
        <p:spPr>
          <a:xfrm>
            <a:off x="8542344" y="1833745"/>
            <a:ext cx="481759" cy="157593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27F4A9B3-BE56-48CD-B453-626BA0547893}"/>
              </a:ext>
            </a:extLst>
          </p:cNvPr>
          <p:cNvSpPr txBox="1"/>
          <p:nvPr/>
        </p:nvSpPr>
        <p:spPr>
          <a:xfrm>
            <a:off x="9107670" y="1495086"/>
            <a:ext cx="5806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RC7-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22E9C4A-8BE0-4BD2-9A70-11073FC21C16}"/>
              </a:ext>
            </a:extLst>
          </p:cNvPr>
          <p:cNvSpPr txBox="1"/>
          <p:nvPr/>
        </p:nvSpPr>
        <p:spPr>
          <a:xfrm>
            <a:off x="8394567" y="196268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EA87F65-5747-4ED7-A53D-A8DFF246CCCC}"/>
              </a:ext>
            </a:extLst>
          </p:cNvPr>
          <p:cNvSpPr txBox="1"/>
          <p:nvPr/>
        </p:nvSpPr>
        <p:spPr>
          <a:xfrm>
            <a:off x="8929968" y="196268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EDBCEC6-8929-44CE-A208-32E85BB10E91}"/>
              </a:ext>
            </a:extLst>
          </p:cNvPr>
          <p:cNvSpPr txBox="1"/>
          <p:nvPr/>
        </p:nvSpPr>
        <p:spPr>
          <a:xfrm rot="16200000">
            <a:off x="8103668" y="1828071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84A5A25-2741-4DD4-BAC9-699FB1699AC9}"/>
              </a:ext>
            </a:extLst>
          </p:cNvPr>
          <p:cNvSpPr txBox="1"/>
          <p:nvPr/>
        </p:nvSpPr>
        <p:spPr>
          <a:xfrm rot="16200000">
            <a:off x="7772172" y="1695895"/>
            <a:ext cx="8258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protein</a:t>
            </a:r>
          </a:p>
        </p:txBody>
      </p:sp>
      <p:sp>
        <p:nvSpPr>
          <p:cNvPr id="63" name="Isosceles Triangle 62">
            <a:extLst>
              <a:ext uri="{FF2B5EF4-FFF2-40B4-BE49-F238E27FC236}">
                <a16:creationId xmlns:a16="http://schemas.microsoft.com/office/drawing/2014/main" id="{E7332B88-430A-4D63-AE77-3513C2C90B79}"/>
              </a:ext>
            </a:extLst>
          </p:cNvPr>
          <p:cNvSpPr/>
          <p:nvPr/>
        </p:nvSpPr>
        <p:spPr>
          <a:xfrm>
            <a:off x="9097718" y="1833745"/>
            <a:ext cx="457312" cy="157593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37F3F2A0-98D8-48AD-850C-6EFDDD384549}"/>
              </a:ext>
            </a:extLst>
          </p:cNvPr>
          <p:cNvSpPr txBox="1"/>
          <p:nvPr/>
        </p:nvSpPr>
        <p:spPr>
          <a:xfrm>
            <a:off x="8580970" y="196268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5E8F6F6-74D4-4A39-BA0B-F5389A99E0E5}"/>
              </a:ext>
            </a:extLst>
          </p:cNvPr>
          <p:cNvSpPr txBox="1"/>
          <p:nvPr/>
        </p:nvSpPr>
        <p:spPr>
          <a:xfrm>
            <a:off x="8747765" y="196268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48EC9EA0-2A84-4DF5-B29A-D05AB56C5038}"/>
              </a:ext>
            </a:extLst>
          </p:cNvPr>
          <p:cNvSpPr txBox="1"/>
          <p:nvPr/>
        </p:nvSpPr>
        <p:spPr>
          <a:xfrm>
            <a:off x="8883369" y="1958896"/>
            <a:ext cx="122177" cy="2192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0905A1E-0679-479F-898E-06117A13E313}"/>
              </a:ext>
            </a:extLst>
          </p:cNvPr>
          <p:cNvSpPr txBox="1"/>
          <p:nvPr/>
        </p:nvSpPr>
        <p:spPr>
          <a:xfrm>
            <a:off x="9137906" y="196268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8CED1D2-4ADB-439E-9B01-E873BF43FEE7}"/>
              </a:ext>
            </a:extLst>
          </p:cNvPr>
          <p:cNvSpPr txBox="1"/>
          <p:nvPr/>
        </p:nvSpPr>
        <p:spPr>
          <a:xfrm>
            <a:off x="9283238" y="196268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3F7585C8-69A8-46C2-BDF0-410F75564E7C}"/>
              </a:ext>
            </a:extLst>
          </p:cNvPr>
          <p:cNvSpPr txBox="1"/>
          <p:nvPr/>
        </p:nvSpPr>
        <p:spPr>
          <a:xfrm>
            <a:off x="9377216" y="1962682"/>
            <a:ext cx="1623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17537472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84</Words>
  <Application>Microsoft Office PowerPoint</Application>
  <PresentationFormat>Widescreen</PresentationFormat>
  <Paragraphs>5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menez Sainz, Judit</dc:creator>
  <cp:lastModifiedBy>Jimenez Sainz, Judit</cp:lastModifiedBy>
  <cp:revision>1</cp:revision>
  <dcterms:created xsi:type="dcterms:W3CDTF">2022-05-05T15:33:52Z</dcterms:created>
  <dcterms:modified xsi:type="dcterms:W3CDTF">2022-05-05T15:39:17Z</dcterms:modified>
</cp:coreProperties>
</file>